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</p:sldIdLst>
  <p:sldSz cx="12192000" cy="6858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5" autoAdjust="0"/>
    <p:restoredTop sz="94660"/>
  </p:normalViewPr>
  <p:slideViewPr>
    <p:cSldViewPr snapToGrid="0">
      <p:cViewPr varScale="1">
        <p:scale>
          <a:sx n="65" d="100"/>
          <a:sy n="65" d="100"/>
        </p:scale>
        <p:origin x="724" y="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DA9BFC-BF88-42CA-BF76-293F2E04E2E6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BB700-A010-4A9D-9542-2B0B49BFD6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5800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DA9BFC-BF88-42CA-BF76-293F2E04E2E6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BB700-A010-4A9D-9542-2B0B49BFD6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2559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DA9BFC-BF88-42CA-BF76-293F2E04E2E6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BB700-A010-4A9D-9542-2B0B49BFD6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168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DA9BFC-BF88-42CA-BF76-293F2E04E2E6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BB700-A010-4A9D-9542-2B0B49BFD6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388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DA9BFC-BF88-42CA-BF76-293F2E04E2E6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BB700-A010-4A9D-9542-2B0B49BFD6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8467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DA9BFC-BF88-42CA-BF76-293F2E04E2E6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BB700-A010-4A9D-9542-2B0B49BFD6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5529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DA9BFC-BF88-42CA-BF76-293F2E04E2E6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BB700-A010-4A9D-9542-2B0B49BFD6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3035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DA9BFC-BF88-42CA-BF76-293F2E04E2E6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BB700-A010-4A9D-9542-2B0B49BFD6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159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DA9BFC-BF88-42CA-BF76-293F2E04E2E6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BB700-A010-4A9D-9542-2B0B49BFD6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1730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DA9BFC-BF88-42CA-BF76-293F2E04E2E6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BB700-A010-4A9D-9542-2B0B49BFD6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080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DA9BFC-BF88-42CA-BF76-293F2E04E2E6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BB700-A010-4A9D-9542-2B0B49BFD6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4404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DA9BFC-BF88-42CA-BF76-293F2E04E2E6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9BB700-A010-4A9D-9542-2B0B49BFD6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017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val 3">
            <a:extLst>
              <a:ext uri="{FF2B5EF4-FFF2-40B4-BE49-F238E27FC236}">
                <a16:creationId xmlns:a16="http://schemas.microsoft.com/office/drawing/2014/main" id="{01168408-A603-4727-B5F8-93BD56A3DDC8}"/>
              </a:ext>
            </a:extLst>
          </p:cNvPr>
          <p:cNvSpPr/>
          <p:nvPr/>
        </p:nvSpPr>
        <p:spPr>
          <a:xfrm>
            <a:off x="393289" y="176981"/>
            <a:ext cx="7285705" cy="6016928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943D7DF6-1D18-48D9-B294-967161915B1C}"/>
              </a:ext>
            </a:extLst>
          </p:cNvPr>
          <p:cNvSpPr/>
          <p:nvPr/>
        </p:nvSpPr>
        <p:spPr>
          <a:xfrm>
            <a:off x="4803057" y="73742"/>
            <a:ext cx="7285705" cy="6016928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56C51CA-4B42-417A-9717-87743FAFAEE8}"/>
              </a:ext>
            </a:extLst>
          </p:cNvPr>
          <p:cNvSpPr txBox="1"/>
          <p:nvPr/>
        </p:nvSpPr>
        <p:spPr>
          <a:xfrm>
            <a:off x="5365135" y="2228671"/>
            <a:ext cx="169606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3 Pathways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ncluding:</a:t>
            </a:r>
          </a:p>
          <a:p>
            <a:pPr algn="ctr"/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PII-coated vesicle buddin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3B4D989-74E5-45EC-A9CE-AC0EBC6CFA9B}"/>
              </a:ext>
            </a:extLst>
          </p:cNvPr>
          <p:cNvSpPr txBox="1"/>
          <p:nvPr/>
        </p:nvSpPr>
        <p:spPr>
          <a:xfrm rot="16200000">
            <a:off x="4884434" y="2855959"/>
            <a:ext cx="77675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0" r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tatin</a:t>
            </a:r>
          </a:p>
        </p:txBody>
      </p:sp>
      <p:sp>
        <p:nvSpPr>
          <p:cNvPr id="11" name="Arrow: Down 10">
            <a:extLst>
              <a:ext uri="{FF2B5EF4-FFF2-40B4-BE49-F238E27FC236}">
                <a16:creationId xmlns:a16="http://schemas.microsoft.com/office/drawing/2014/main" id="{283481DA-D868-49DA-81DF-5085A3010783}"/>
              </a:ext>
            </a:extLst>
          </p:cNvPr>
          <p:cNvSpPr/>
          <p:nvPr/>
        </p:nvSpPr>
        <p:spPr>
          <a:xfrm rot="10800000">
            <a:off x="5109349" y="2376947"/>
            <a:ext cx="369332" cy="275303"/>
          </a:xfrm>
          <a:prstGeom prst="downArrow">
            <a:avLst/>
          </a:prstGeom>
          <a:solidFill>
            <a:srgbClr val="FF0000"/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8999D13-FA7B-42CF-8DC7-2A6457C7E5B7}"/>
              </a:ext>
            </a:extLst>
          </p:cNvPr>
          <p:cNvSpPr txBox="1"/>
          <p:nvPr/>
        </p:nvSpPr>
        <p:spPr>
          <a:xfrm rot="5400000">
            <a:off x="10801346" y="2392414"/>
            <a:ext cx="133924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0" r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ymeglusin</a:t>
            </a:r>
          </a:p>
        </p:txBody>
      </p:sp>
      <p:sp>
        <p:nvSpPr>
          <p:cNvPr id="13" name="Arrow: Down 12">
            <a:extLst>
              <a:ext uri="{FF2B5EF4-FFF2-40B4-BE49-F238E27FC236}">
                <a16:creationId xmlns:a16="http://schemas.microsoft.com/office/drawing/2014/main" id="{6DE952DE-B812-4B19-9C22-CF759804FDD0}"/>
              </a:ext>
            </a:extLst>
          </p:cNvPr>
          <p:cNvSpPr/>
          <p:nvPr/>
        </p:nvSpPr>
        <p:spPr>
          <a:xfrm>
            <a:off x="11284395" y="3247967"/>
            <a:ext cx="369332" cy="275303"/>
          </a:xfrm>
          <a:prstGeom prst="downArrow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5C5FACF-480D-42D0-BDAD-42276276CDC2}"/>
              </a:ext>
            </a:extLst>
          </p:cNvPr>
          <p:cNvSpPr txBox="1"/>
          <p:nvPr/>
        </p:nvSpPr>
        <p:spPr>
          <a:xfrm rot="16200000">
            <a:off x="382326" y="2950229"/>
            <a:ext cx="77675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0" r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tatin</a:t>
            </a:r>
          </a:p>
        </p:txBody>
      </p:sp>
      <p:sp>
        <p:nvSpPr>
          <p:cNvPr id="20" name="Arrow: Down 19">
            <a:extLst>
              <a:ext uri="{FF2B5EF4-FFF2-40B4-BE49-F238E27FC236}">
                <a16:creationId xmlns:a16="http://schemas.microsoft.com/office/drawing/2014/main" id="{A056E251-6C51-4FCE-8922-5BEC9A94960A}"/>
              </a:ext>
            </a:extLst>
          </p:cNvPr>
          <p:cNvSpPr/>
          <p:nvPr/>
        </p:nvSpPr>
        <p:spPr>
          <a:xfrm rot="10800000">
            <a:off x="607241" y="2471217"/>
            <a:ext cx="369332" cy="275303"/>
          </a:xfrm>
          <a:prstGeom prst="downArrow">
            <a:avLst/>
          </a:prstGeom>
          <a:solidFill>
            <a:srgbClr val="FF0000"/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838233F-DA9A-4039-85EE-C9DE9AEB418E}"/>
              </a:ext>
            </a:extLst>
          </p:cNvPr>
          <p:cNvSpPr txBox="1"/>
          <p:nvPr/>
        </p:nvSpPr>
        <p:spPr>
          <a:xfrm>
            <a:off x="1794811" y="1301935"/>
            <a:ext cx="2565796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32 Pathways including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5 Golgi/membrane related: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ER to Golgi transport vesicle membrane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secretory vesicle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eutrophil degranulation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eutrophil activation involved in immune response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eutrophil mediated immunity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4CFB147-6933-41B5-92A7-38FF625520E2}"/>
              </a:ext>
            </a:extLst>
          </p:cNvPr>
          <p:cNvSpPr txBox="1"/>
          <p:nvPr/>
        </p:nvSpPr>
        <p:spPr>
          <a:xfrm rot="5400000">
            <a:off x="6501416" y="2558100"/>
            <a:ext cx="136993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0" r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ymeglusin</a:t>
            </a:r>
          </a:p>
        </p:txBody>
      </p:sp>
      <p:sp>
        <p:nvSpPr>
          <p:cNvPr id="25" name="Arrow: Down 24">
            <a:extLst>
              <a:ext uri="{FF2B5EF4-FFF2-40B4-BE49-F238E27FC236}">
                <a16:creationId xmlns:a16="http://schemas.microsoft.com/office/drawing/2014/main" id="{D79C7BED-EC02-455B-BE55-C29FEABF0131}"/>
              </a:ext>
            </a:extLst>
          </p:cNvPr>
          <p:cNvSpPr/>
          <p:nvPr/>
        </p:nvSpPr>
        <p:spPr>
          <a:xfrm>
            <a:off x="6999812" y="3429000"/>
            <a:ext cx="369332" cy="275303"/>
          </a:xfrm>
          <a:prstGeom prst="downArrow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9E7B654-BD2E-4215-8B6D-C098DD045A18}"/>
              </a:ext>
            </a:extLst>
          </p:cNvPr>
          <p:cNvSpPr txBox="1"/>
          <p:nvPr/>
        </p:nvSpPr>
        <p:spPr>
          <a:xfrm>
            <a:off x="7503650" y="681549"/>
            <a:ext cx="3778837" cy="48013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19 Pathways including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9 Golgi/membrane related: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Golgi-associated vesicle 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ndoplasmic reticulum-Golgi intermediate compartment membrane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sicle coating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PII vesicle coating 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sicle targeting, rough ER to cis-Golgi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ndoplasmic reticulum-Golgi intermediate compartment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rans-Golgi network transport vesicle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ated vesicle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PII-coated ER to Golgi transport vesicl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02080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val 3">
            <a:extLst>
              <a:ext uri="{FF2B5EF4-FFF2-40B4-BE49-F238E27FC236}">
                <a16:creationId xmlns:a16="http://schemas.microsoft.com/office/drawing/2014/main" id="{01168408-A603-4727-B5F8-93BD56A3DDC8}"/>
              </a:ext>
            </a:extLst>
          </p:cNvPr>
          <p:cNvSpPr/>
          <p:nvPr/>
        </p:nvSpPr>
        <p:spPr>
          <a:xfrm>
            <a:off x="393289" y="176981"/>
            <a:ext cx="7285705" cy="6016928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943D7DF6-1D18-48D9-B294-967161915B1C}"/>
              </a:ext>
            </a:extLst>
          </p:cNvPr>
          <p:cNvSpPr/>
          <p:nvPr/>
        </p:nvSpPr>
        <p:spPr>
          <a:xfrm>
            <a:off x="4803057" y="73742"/>
            <a:ext cx="7285705" cy="6016928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56C51CA-4B42-417A-9717-87743FAFAEE8}"/>
              </a:ext>
            </a:extLst>
          </p:cNvPr>
          <p:cNvSpPr txBox="1"/>
          <p:nvPr/>
        </p:nvSpPr>
        <p:spPr>
          <a:xfrm>
            <a:off x="5329340" y="1868227"/>
            <a:ext cx="16960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No Pathway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3B4D989-74E5-45EC-A9CE-AC0EBC6CFA9B}"/>
              </a:ext>
            </a:extLst>
          </p:cNvPr>
          <p:cNvSpPr txBox="1"/>
          <p:nvPr/>
        </p:nvSpPr>
        <p:spPr>
          <a:xfrm rot="16200000">
            <a:off x="4884434" y="2855959"/>
            <a:ext cx="77675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0" r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tatin</a:t>
            </a:r>
          </a:p>
        </p:txBody>
      </p:sp>
      <p:sp>
        <p:nvSpPr>
          <p:cNvPr id="11" name="Arrow: Down 10">
            <a:extLst>
              <a:ext uri="{FF2B5EF4-FFF2-40B4-BE49-F238E27FC236}">
                <a16:creationId xmlns:a16="http://schemas.microsoft.com/office/drawing/2014/main" id="{283481DA-D868-49DA-81DF-5085A3010783}"/>
              </a:ext>
            </a:extLst>
          </p:cNvPr>
          <p:cNvSpPr/>
          <p:nvPr/>
        </p:nvSpPr>
        <p:spPr>
          <a:xfrm rot="10800000">
            <a:off x="5275350" y="2169667"/>
            <a:ext cx="369332" cy="275303"/>
          </a:xfrm>
          <a:prstGeom prst="downArrow">
            <a:avLst/>
          </a:prstGeom>
          <a:solidFill>
            <a:srgbClr val="FF0000"/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8999D13-FA7B-42CF-8DC7-2A6457C7E5B7}"/>
              </a:ext>
            </a:extLst>
          </p:cNvPr>
          <p:cNvSpPr txBox="1"/>
          <p:nvPr/>
        </p:nvSpPr>
        <p:spPr>
          <a:xfrm rot="5400000">
            <a:off x="10781730" y="2372798"/>
            <a:ext cx="137847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0" r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ymeglusin</a:t>
            </a:r>
          </a:p>
        </p:txBody>
      </p:sp>
      <p:sp>
        <p:nvSpPr>
          <p:cNvPr id="13" name="Arrow: Down 12">
            <a:extLst>
              <a:ext uri="{FF2B5EF4-FFF2-40B4-BE49-F238E27FC236}">
                <a16:creationId xmlns:a16="http://schemas.microsoft.com/office/drawing/2014/main" id="{6DE952DE-B812-4B19-9C22-CF759804FDD0}"/>
              </a:ext>
            </a:extLst>
          </p:cNvPr>
          <p:cNvSpPr/>
          <p:nvPr/>
        </p:nvSpPr>
        <p:spPr>
          <a:xfrm>
            <a:off x="11284395" y="3247967"/>
            <a:ext cx="369332" cy="275303"/>
          </a:xfrm>
          <a:prstGeom prst="downArrow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5C5FACF-480D-42D0-BDAD-42276276CDC2}"/>
              </a:ext>
            </a:extLst>
          </p:cNvPr>
          <p:cNvSpPr txBox="1"/>
          <p:nvPr/>
        </p:nvSpPr>
        <p:spPr>
          <a:xfrm rot="16200000">
            <a:off x="382326" y="2950229"/>
            <a:ext cx="77675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0" r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tatin</a:t>
            </a:r>
          </a:p>
        </p:txBody>
      </p:sp>
      <p:sp>
        <p:nvSpPr>
          <p:cNvPr id="20" name="Arrow: Down 19">
            <a:extLst>
              <a:ext uri="{FF2B5EF4-FFF2-40B4-BE49-F238E27FC236}">
                <a16:creationId xmlns:a16="http://schemas.microsoft.com/office/drawing/2014/main" id="{A056E251-6C51-4FCE-8922-5BEC9A94960A}"/>
              </a:ext>
            </a:extLst>
          </p:cNvPr>
          <p:cNvSpPr/>
          <p:nvPr/>
        </p:nvSpPr>
        <p:spPr>
          <a:xfrm rot="10800000">
            <a:off x="791853" y="2228671"/>
            <a:ext cx="369332" cy="275303"/>
          </a:xfrm>
          <a:prstGeom prst="downArrow">
            <a:avLst/>
          </a:prstGeom>
          <a:solidFill>
            <a:srgbClr val="FF0000"/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838233F-DA9A-4039-85EE-C9DE9AEB418E}"/>
              </a:ext>
            </a:extLst>
          </p:cNvPr>
          <p:cNvSpPr txBox="1"/>
          <p:nvPr/>
        </p:nvSpPr>
        <p:spPr>
          <a:xfrm>
            <a:off x="1794811" y="1301935"/>
            <a:ext cx="2565796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5 Pathways including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4 Golgi/membrane related: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cretory granule lume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eutrophil degranulation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eutrophil activation involved in immune response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eutrophil mediated immunity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4CFB147-6933-41B5-92A7-38FF625520E2}"/>
              </a:ext>
            </a:extLst>
          </p:cNvPr>
          <p:cNvSpPr txBox="1"/>
          <p:nvPr/>
        </p:nvSpPr>
        <p:spPr>
          <a:xfrm rot="5400000">
            <a:off x="6421194" y="2525192"/>
            <a:ext cx="135312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0" r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ymeglusin</a:t>
            </a:r>
          </a:p>
        </p:txBody>
      </p:sp>
      <p:sp>
        <p:nvSpPr>
          <p:cNvPr id="25" name="Arrow: Down 24">
            <a:extLst>
              <a:ext uri="{FF2B5EF4-FFF2-40B4-BE49-F238E27FC236}">
                <a16:creationId xmlns:a16="http://schemas.microsoft.com/office/drawing/2014/main" id="{D79C7BED-EC02-455B-BE55-C29FEABF0131}"/>
              </a:ext>
            </a:extLst>
          </p:cNvPr>
          <p:cNvSpPr/>
          <p:nvPr/>
        </p:nvSpPr>
        <p:spPr>
          <a:xfrm>
            <a:off x="6913093" y="3385618"/>
            <a:ext cx="369332" cy="275303"/>
          </a:xfrm>
          <a:prstGeom prst="downArrow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9E7B654-BD2E-4215-8B6D-C098DD045A18}"/>
              </a:ext>
            </a:extLst>
          </p:cNvPr>
          <p:cNvSpPr txBox="1"/>
          <p:nvPr/>
        </p:nvSpPr>
        <p:spPr>
          <a:xfrm>
            <a:off x="7503650" y="681549"/>
            <a:ext cx="3778837" cy="48013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15 Pathways including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9 Golgi/membrane related: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Golgi-associated vesicle 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ndoplasmic reticulum-Golgi intermediate compartment membrane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sicle coating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PII vesicle coating 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sicle targeting, rough ER to cis-Golgi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ndoplasmic reticulum-Golgi intermediate compartment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rans-Golgi network transport vesicle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ated vesicle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PII-coated ER to Golgi transport vesicl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3975070-87DC-45B0-A1A0-2CD2C4ECDB14}"/>
              </a:ext>
            </a:extLst>
          </p:cNvPr>
          <p:cNvSpPr txBox="1"/>
          <p:nvPr/>
        </p:nvSpPr>
        <p:spPr>
          <a:xfrm rot="16200000">
            <a:off x="563992" y="3000778"/>
            <a:ext cx="121587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0" r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etformin</a:t>
            </a:r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417BE59D-D0CF-4DFD-B46A-865ADA6242F5}"/>
              </a:ext>
            </a:extLst>
          </p:cNvPr>
          <p:cNvSpPr/>
          <p:nvPr/>
        </p:nvSpPr>
        <p:spPr>
          <a:xfrm>
            <a:off x="488066" y="303696"/>
            <a:ext cx="7092959" cy="5763496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36F27AE-CDF6-4589-849A-A2294BCEBF5F}"/>
              </a:ext>
            </a:extLst>
          </p:cNvPr>
          <p:cNvSpPr txBox="1"/>
          <p:nvPr/>
        </p:nvSpPr>
        <p:spPr>
          <a:xfrm rot="16200000">
            <a:off x="5091040" y="2950229"/>
            <a:ext cx="121587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0" r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etformin</a:t>
            </a:r>
          </a:p>
        </p:txBody>
      </p:sp>
    </p:spTree>
    <p:extLst>
      <p:ext uri="{BB962C8B-B14F-4D97-AF65-F5344CB8AC3E}">
        <p14:creationId xmlns:p14="http://schemas.microsoft.com/office/powerpoint/2010/main" val="8474017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</TotalTime>
  <Words>166</Words>
  <Application>Microsoft Office PowerPoint</Application>
  <PresentationFormat>Widescreen</PresentationFormat>
  <Paragraphs>4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c Trub</dc:creator>
  <cp:lastModifiedBy>Alec Trub</cp:lastModifiedBy>
  <cp:revision>5</cp:revision>
  <dcterms:created xsi:type="dcterms:W3CDTF">2021-12-13T21:14:03Z</dcterms:created>
  <dcterms:modified xsi:type="dcterms:W3CDTF">2021-12-13T22:29:07Z</dcterms:modified>
</cp:coreProperties>
</file>